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86" d="100"/>
          <a:sy n="86" d="100"/>
        </p:scale>
        <p:origin x="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4BD3C1-1A39-4E34-B4B7-0884DA9B9D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1B81CB-A0D0-4866-9A6C-570E9CD1E8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F892E2-3F0E-41F0-84F3-817250DF7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B858C9-972A-43B6-BB72-466E05CAD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B0A69B-E08C-4EE0-914B-A0635004AF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14095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3982AD-5C7B-408D-A522-443CE85C00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81EF1A-C7F3-4F20-B36C-A09E81B3EA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D0F920-7F6A-40FE-8ABA-B60C31199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AE8559-FAE6-4524-90B6-02E0E5B50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B02B4E-F819-4A94-B46E-C92D47E3D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601358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6C79F8C-EE61-4626-A605-4CACE66D2A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101999-3CCD-4A31-84E1-077C850A2A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7871BF-A4EC-45E2-83C9-977CF51106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E98FCC-CC89-41CD-8416-CB906ABA1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C76DD1-F2AD-4E0D-BB08-C9701F893C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70386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75E110-2905-48FE-859D-29BCE7500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CD38C7-F8BE-4636-BB33-A8A36CE9A4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DF8A8-827E-4DE7-9CC1-41351671E8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5BDD60-6FDF-490F-AA2B-3755DCA94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EFDD91-3F8E-46CC-B197-5BA052532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565088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49E74-B941-40EA-A9C4-36FDC39791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061918-37B2-457B-A38C-D754EF8306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D720DF-EA3C-4ADC-BD9C-00690B127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F77C4F-52F8-40DC-8A7A-842C70C19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423857-6AE6-476C-8DC4-077DFF487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39551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7F79CB-D0DD-454E-B070-FEC9D64EE9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098FB5-21E3-4448-A543-4306570F32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ADEBB5-43A2-469C-9A8F-F05E95A8B5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CB7091-77CB-4D08-90BE-53B6394F0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AF25C0-44D9-4A2B-9C97-9F2F82451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413CC6-045C-42AB-AEF6-AC178AB9BE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03902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A0FC26-F778-430B-B5E4-15EE498459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23D030-5341-41AF-AE8A-12FF343DF2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C463A5-09D2-489F-B734-4F43AA18BB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4BE663-2A7B-4F5D-B4E5-0A6362B970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F5D1382-E077-4EAA-A8FD-76CABC66CF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55915E2-0088-4BCA-A038-8F39AE6B7F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E37AB7B-4757-4AEE-94F0-3E47157B3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D06AEB-024D-4AB0-8A7D-B0CF3B0A2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10201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DEE1F4-4181-4923-8037-6AE936C575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18EE40-A67E-4772-88CF-6708E8353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7CB4C3E-5822-41E8-9E57-6D568F805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E363FB-09DA-4612-B77F-131423A63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104377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485B61-24C1-4941-AA54-62A66A19EB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BEA57D2-D6FB-4684-98FE-4A1866309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4B70C7-0365-43E2-83AB-E2FD8F008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051199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D7A224-884C-4DFE-B4FE-88AF818AE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9709DC-64A1-42A9-8638-04189A5B22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1592F3-D6C1-482F-8BA6-A86A7517D6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E3AFA8-2FC9-4704-B60F-3966143EC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98735F-BB82-4309-A74C-CBAFCB596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FEFAB4-33D8-4D0D-A445-9ABF696C1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286189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C5FDCD-01B1-42F4-844D-DBE7877A37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FA4D78-5777-40BD-BE72-A8DFAB194C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A675F1-2B46-4027-964E-0E591DF74E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187415-B8C9-4D8E-A760-01314C544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DE803B-E02A-4CA4-880F-601FC8CFC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EDFA12-A211-4579-8E84-024077F0D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744749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2BAE03C-25B5-4426-BFCD-CECD0784D2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499FE2-FD30-45D6-9687-41A46741AB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D738D3-7EA9-4386-9FBC-DDE447E16A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A54EF-5360-4C04-8FC9-A14673DDE1D9}" type="datetimeFigureOut">
              <a:rPr lang="fi-FI" smtClean="0"/>
              <a:t>26.8.2024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EDD961-3C52-40B3-A9A2-AB4C831A17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39B91E-3641-4B00-8FDE-EB465B1EDF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07FA01-9E5F-46EA-8B19-5C74275AAC3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934104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EB6CA13-A964-456B-A055-5EC8CD30B9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811" y="184484"/>
            <a:ext cx="16308406" cy="599974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72592A9A-80FB-4584-B120-8E073A220733}"/>
              </a:ext>
            </a:extLst>
          </p:cNvPr>
          <p:cNvSpPr/>
          <p:nvPr/>
        </p:nvSpPr>
        <p:spPr>
          <a:xfrm>
            <a:off x="6312568" y="4170947"/>
            <a:ext cx="3521243" cy="1997242"/>
          </a:xfrm>
          <a:prstGeom prst="rect">
            <a:avLst/>
          </a:prstGeom>
          <a:noFill/>
          <a:ln w="3810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05DCF58-AB49-4182-AD8B-ECCC8A0CBA90}"/>
              </a:ext>
            </a:extLst>
          </p:cNvPr>
          <p:cNvSpPr/>
          <p:nvPr/>
        </p:nvSpPr>
        <p:spPr>
          <a:xfrm>
            <a:off x="6312567" y="3609473"/>
            <a:ext cx="3521243" cy="561473"/>
          </a:xfrm>
          <a:prstGeom prst="rect">
            <a:avLst/>
          </a:prstGeom>
          <a:noFill/>
          <a:ln w="3810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DBF38EF-7350-46EC-BB67-41AED058078D}"/>
              </a:ext>
            </a:extLst>
          </p:cNvPr>
          <p:cNvSpPr txBox="1"/>
          <p:nvPr/>
        </p:nvSpPr>
        <p:spPr>
          <a:xfrm>
            <a:off x="10800349" y="4978677"/>
            <a:ext cx="14076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 err="1"/>
              <a:t>Lettuce</a:t>
            </a:r>
            <a:r>
              <a:rPr lang="fi-FI" dirty="0"/>
              <a:t> </a:t>
            </a:r>
            <a:r>
              <a:rPr lang="fi-FI" dirty="0" err="1"/>
              <a:t>ELIPs</a:t>
            </a:r>
            <a:endParaRPr lang="fi-FI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B9FACE3-A952-49F7-BD37-B5A5612BB094}"/>
              </a:ext>
            </a:extLst>
          </p:cNvPr>
          <p:cNvSpPr txBox="1"/>
          <p:nvPr/>
        </p:nvSpPr>
        <p:spPr>
          <a:xfrm>
            <a:off x="9970167" y="3705543"/>
            <a:ext cx="1800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 err="1"/>
              <a:t>Arabidopsis</a:t>
            </a:r>
            <a:r>
              <a:rPr lang="fi-FI" dirty="0"/>
              <a:t> </a:t>
            </a:r>
            <a:r>
              <a:rPr lang="fi-FI" dirty="0" err="1"/>
              <a:t>ELIPs</a:t>
            </a:r>
            <a:endParaRPr lang="fi-FI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A9D3B2E-62FF-44DD-93F5-8CD4BE779A9F}"/>
              </a:ext>
            </a:extLst>
          </p:cNvPr>
          <p:cNvSpPr txBox="1"/>
          <p:nvPr/>
        </p:nvSpPr>
        <p:spPr>
          <a:xfrm>
            <a:off x="9833809" y="5577233"/>
            <a:ext cx="1165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ELIP1.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40A21EA-A4F8-4B41-8735-F84A51CBF289}"/>
              </a:ext>
            </a:extLst>
          </p:cNvPr>
          <p:cNvSpPr txBox="1"/>
          <p:nvPr/>
        </p:nvSpPr>
        <p:spPr>
          <a:xfrm>
            <a:off x="9822037" y="4984902"/>
            <a:ext cx="1165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/>
              <a:t>Ls_ELIP1.2</a:t>
            </a:r>
            <a:endParaRPr lang="fi-FI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7CCDCAF-8B30-4CD4-A308-B520DF651BC8}"/>
              </a:ext>
            </a:extLst>
          </p:cNvPr>
          <p:cNvSpPr txBox="1"/>
          <p:nvPr/>
        </p:nvSpPr>
        <p:spPr>
          <a:xfrm>
            <a:off x="9828834" y="5276976"/>
            <a:ext cx="1165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ELIP1.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D0DEA67-5220-4B2B-AAA2-01F963AAB1E1}"/>
              </a:ext>
            </a:extLst>
          </p:cNvPr>
          <p:cNvSpPr txBox="1"/>
          <p:nvPr/>
        </p:nvSpPr>
        <p:spPr>
          <a:xfrm>
            <a:off x="9838784" y="5837599"/>
            <a:ext cx="1165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ELIP1.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6D7078D-7842-4A90-80AE-C5965301AEBD}"/>
              </a:ext>
            </a:extLst>
          </p:cNvPr>
          <p:cNvSpPr txBox="1"/>
          <p:nvPr/>
        </p:nvSpPr>
        <p:spPr>
          <a:xfrm>
            <a:off x="9823856" y="4423284"/>
            <a:ext cx="1165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ELIP1.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86945F1-2FF9-40FF-8646-C6340B797563}"/>
              </a:ext>
            </a:extLst>
          </p:cNvPr>
          <p:cNvSpPr txBox="1"/>
          <p:nvPr/>
        </p:nvSpPr>
        <p:spPr>
          <a:xfrm>
            <a:off x="9822038" y="4718762"/>
            <a:ext cx="1165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ELIP1.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11655D0-7552-4E75-869F-D0B47BDA8697}"/>
              </a:ext>
            </a:extLst>
          </p:cNvPr>
          <p:cNvSpPr txBox="1"/>
          <p:nvPr/>
        </p:nvSpPr>
        <p:spPr>
          <a:xfrm>
            <a:off x="9825674" y="4151869"/>
            <a:ext cx="1165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ELIP1.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027A009-C806-4DA6-9227-9EF4BAB11784}"/>
              </a:ext>
            </a:extLst>
          </p:cNvPr>
          <p:cNvSpPr txBox="1"/>
          <p:nvPr/>
        </p:nvSpPr>
        <p:spPr>
          <a:xfrm>
            <a:off x="9822037" y="3220620"/>
            <a:ext cx="1019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OHP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B375B18-352D-4074-9706-F0F3AB82890E}"/>
              </a:ext>
            </a:extLst>
          </p:cNvPr>
          <p:cNvSpPr txBox="1"/>
          <p:nvPr/>
        </p:nvSpPr>
        <p:spPr>
          <a:xfrm>
            <a:off x="9822037" y="389189"/>
            <a:ext cx="11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OHP2.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4B38BE9-9891-4A31-AA89-667507C719ED}"/>
              </a:ext>
            </a:extLst>
          </p:cNvPr>
          <p:cNvSpPr txBox="1"/>
          <p:nvPr/>
        </p:nvSpPr>
        <p:spPr>
          <a:xfrm>
            <a:off x="9822037" y="670147"/>
            <a:ext cx="11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OHP2.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AACB81D-670D-4BB5-B0A0-25CA11839A17}"/>
              </a:ext>
            </a:extLst>
          </p:cNvPr>
          <p:cNvSpPr txBox="1"/>
          <p:nvPr/>
        </p:nvSpPr>
        <p:spPr>
          <a:xfrm>
            <a:off x="9822037" y="989688"/>
            <a:ext cx="1032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LIL3.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83A9D69-D508-4517-B4FE-46E0F32C3AA4}"/>
              </a:ext>
            </a:extLst>
          </p:cNvPr>
          <p:cNvSpPr txBox="1"/>
          <p:nvPr/>
        </p:nvSpPr>
        <p:spPr>
          <a:xfrm>
            <a:off x="9822037" y="1261103"/>
            <a:ext cx="1032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LIL3.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81DEBC1-9E55-42AA-98CC-7EDCB5160614}"/>
              </a:ext>
            </a:extLst>
          </p:cNvPr>
          <p:cNvSpPr txBox="1"/>
          <p:nvPr/>
        </p:nvSpPr>
        <p:spPr>
          <a:xfrm>
            <a:off x="9815624" y="1818513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SEP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EFF010F-2B37-485C-9456-2C1AD3402F84}"/>
              </a:ext>
            </a:extLst>
          </p:cNvPr>
          <p:cNvSpPr txBox="1"/>
          <p:nvPr/>
        </p:nvSpPr>
        <p:spPr>
          <a:xfrm>
            <a:off x="9815623" y="2413815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Ls_SEP1</a:t>
            </a:r>
          </a:p>
        </p:txBody>
      </p:sp>
    </p:spTree>
    <p:extLst>
      <p:ext uri="{BB962C8B-B14F-4D97-AF65-F5344CB8AC3E}">
        <p14:creationId xmlns:p14="http://schemas.microsoft.com/office/powerpoint/2010/main" val="32734232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584CB06-CEF0-4FA8-8FBA-8DB4256CDE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0922" y="-1"/>
            <a:ext cx="7932832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BBFC597-31CA-46AF-B7E6-78FE2AAF5773}"/>
              </a:ext>
            </a:extLst>
          </p:cNvPr>
          <p:cNvSpPr/>
          <p:nvPr/>
        </p:nvSpPr>
        <p:spPr>
          <a:xfrm>
            <a:off x="6023811" y="5871410"/>
            <a:ext cx="1660358" cy="986589"/>
          </a:xfrm>
          <a:prstGeom prst="rect">
            <a:avLst/>
          </a:prstGeom>
          <a:noFill/>
          <a:ln w="3810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8D7199F-27CC-4DAD-9E47-E15DE6BB9A37}"/>
              </a:ext>
            </a:extLst>
          </p:cNvPr>
          <p:cNvSpPr/>
          <p:nvPr/>
        </p:nvSpPr>
        <p:spPr>
          <a:xfrm>
            <a:off x="6023811" y="5165558"/>
            <a:ext cx="1660358" cy="705851"/>
          </a:xfrm>
          <a:prstGeom prst="rect">
            <a:avLst/>
          </a:prstGeom>
          <a:noFill/>
          <a:ln w="3810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0DD49E2-34EE-4F57-9864-CEB24285DE66}"/>
              </a:ext>
            </a:extLst>
          </p:cNvPr>
          <p:cNvSpPr txBox="1"/>
          <p:nvPr/>
        </p:nvSpPr>
        <p:spPr>
          <a:xfrm>
            <a:off x="7748336" y="6180038"/>
            <a:ext cx="14465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 err="1"/>
              <a:t>Lettuce</a:t>
            </a:r>
            <a:r>
              <a:rPr lang="fi-FI" dirty="0"/>
              <a:t> lhcb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1CEDDDA-615B-48C1-BB88-D1D8FC9D284E}"/>
              </a:ext>
            </a:extLst>
          </p:cNvPr>
          <p:cNvSpPr txBox="1"/>
          <p:nvPr/>
        </p:nvSpPr>
        <p:spPr>
          <a:xfrm>
            <a:off x="7748336" y="5333817"/>
            <a:ext cx="17497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 err="1"/>
              <a:t>Arabidopsi</a:t>
            </a:r>
            <a:r>
              <a:rPr lang="fi-FI" dirty="0"/>
              <a:t> lhcb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AAE325A-4250-41FB-BFE7-167E16D568D8}"/>
              </a:ext>
            </a:extLst>
          </p:cNvPr>
          <p:cNvSpPr txBox="1"/>
          <p:nvPr/>
        </p:nvSpPr>
        <p:spPr>
          <a:xfrm>
            <a:off x="7711467" y="376056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dirty="0"/>
              <a:t>Ls_Lhcb6.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51D4E8B-4F1B-47DE-8732-550DAA0C257E}"/>
              </a:ext>
            </a:extLst>
          </p:cNvPr>
          <p:cNvSpPr txBox="1"/>
          <p:nvPr/>
        </p:nvSpPr>
        <p:spPr>
          <a:xfrm>
            <a:off x="7716230" y="499166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dirty="0"/>
              <a:t>Ls_Lhcb6.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BF50F8B-8241-474C-9CE0-9B6794A8E165}"/>
              </a:ext>
            </a:extLst>
          </p:cNvPr>
          <p:cNvSpPr txBox="1"/>
          <p:nvPr/>
        </p:nvSpPr>
        <p:spPr>
          <a:xfrm>
            <a:off x="7711467" y="953480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dirty="0"/>
              <a:t>Ls_Lhcb4.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DBF66D0-D072-48C2-810C-501AE51EE65C}"/>
              </a:ext>
            </a:extLst>
          </p:cNvPr>
          <p:cNvSpPr txBox="1"/>
          <p:nvPr/>
        </p:nvSpPr>
        <p:spPr>
          <a:xfrm>
            <a:off x="7711467" y="807425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dirty="0"/>
              <a:t>Ls_Lhcb4.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94D91BF-9539-4992-B00D-747AD1BFE706}"/>
              </a:ext>
            </a:extLst>
          </p:cNvPr>
          <p:cNvSpPr txBox="1"/>
          <p:nvPr/>
        </p:nvSpPr>
        <p:spPr>
          <a:xfrm>
            <a:off x="7654317" y="3388035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dirty="0"/>
              <a:t>Ls_Lhcb5.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76E5807-2EBA-4D8E-856F-959B506382DA}"/>
              </a:ext>
            </a:extLst>
          </p:cNvPr>
          <p:cNvSpPr txBox="1"/>
          <p:nvPr/>
        </p:nvSpPr>
        <p:spPr>
          <a:xfrm>
            <a:off x="7654317" y="3241980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dirty="0"/>
              <a:t>Ls_Lhcb5.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0B2FE53-F0E0-4DD6-87A7-301847D49993}"/>
              </a:ext>
            </a:extLst>
          </p:cNvPr>
          <p:cNvSpPr txBox="1"/>
          <p:nvPr/>
        </p:nvSpPr>
        <p:spPr>
          <a:xfrm>
            <a:off x="7654317" y="4106382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dirty="0"/>
              <a:t>Ls_Lhcb3.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9E3D4DE-7733-4D4D-B27F-45B22A91D1BF}"/>
              </a:ext>
            </a:extLst>
          </p:cNvPr>
          <p:cNvSpPr txBox="1"/>
          <p:nvPr/>
        </p:nvSpPr>
        <p:spPr>
          <a:xfrm>
            <a:off x="7654317" y="3960327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dirty="0"/>
              <a:t>Ls_Lhcb3.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1941BB0-A517-44E3-8439-581E9905DB6A}"/>
              </a:ext>
            </a:extLst>
          </p:cNvPr>
          <p:cNvSpPr txBox="1"/>
          <p:nvPr/>
        </p:nvSpPr>
        <p:spPr>
          <a:xfrm>
            <a:off x="7654317" y="4378647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dirty="0"/>
              <a:t>Ls_Lhcb2.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A41C556-04A8-4D8C-88CC-40CEF4A6E4AD}"/>
              </a:ext>
            </a:extLst>
          </p:cNvPr>
          <p:cNvSpPr txBox="1"/>
          <p:nvPr/>
        </p:nvSpPr>
        <p:spPr>
          <a:xfrm>
            <a:off x="7654317" y="4232592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dirty="0"/>
              <a:t>Ls_Lhcb2.1</a:t>
            </a:r>
          </a:p>
        </p:txBody>
      </p:sp>
    </p:spTree>
    <p:extLst>
      <p:ext uri="{BB962C8B-B14F-4D97-AF65-F5344CB8AC3E}">
        <p14:creationId xmlns:p14="http://schemas.microsoft.com/office/powerpoint/2010/main" val="3651790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80</Words>
  <Application>Microsoft Office PowerPoint</Application>
  <PresentationFormat>Widescreen</PresentationFormat>
  <Paragraphs>2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pio Lempiäinen</dc:creator>
  <cp:lastModifiedBy>Tapio Lempiäinen</cp:lastModifiedBy>
  <cp:revision>10</cp:revision>
  <dcterms:created xsi:type="dcterms:W3CDTF">2023-04-20T11:09:00Z</dcterms:created>
  <dcterms:modified xsi:type="dcterms:W3CDTF">2024-08-26T13:08:44Z</dcterms:modified>
</cp:coreProperties>
</file>